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0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85698" autoAdjust="0"/>
  </p:normalViewPr>
  <p:slideViewPr>
    <p:cSldViewPr>
      <p:cViewPr varScale="1">
        <p:scale>
          <a:sx n="62" d="100"/>
          <a:sy n="62" d="100"/>
        </p:scale>
        <p:origin x="1626" y="4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9E1626A-E5DB-4888-B6E9-B84407C3E8EF}" type="datetimeFigureOut">
              <a:rPr lang="en-US" smtClean="0"/>
              <a:t>5/15/20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66D5A9F-0F10-4483-BDCF-6A090BBB428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5815406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Supplementary Figure 8:</a:t>
            </a:r>
            <a:r>
              <a:rPr lang="en-US" baseline="0" dirty="0"/>
              <a:t>  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Chromosomal microarray performed on DNA extracted from FFPE tissue using the </a:t>
            </a:r>
            <a:r>
              <a:rPr lang="en-US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OncoScan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CNV Plus assay for PSTT-2</a:t>
            </a:r>
          </a:p>
          <a:p>
            <a:endParaRPr lang="en-US" sz="12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PSTT-2</a:t>
            </a:r>
            <a:r>
              <a:rPr lang="en-US" baseline="0" dirty="0"/>
              <a:t> 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was classified as negative for copy number alterations and genomic deletions affecting </a:t>
            </a:r>
            <a:r>
              <a:rPr lang="en-US" sz="1200" i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LPCAT1 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or </a:t>
            </a:r>
            <a:r>
              <a:rPr lang="en-US" sz="1200" i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TERT.</a:t>
            </a:r>
            <a:endParaRPr lang="en-US" dirty="0"/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66D5A9F-0F10-4483-BDCF-6A090BBB4288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2731588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5831E4-474B-4F25-B22E-82D05E314CF4}" type="datetimeFigureOut">
              <a:rPr lang="en-US" smtClean="0"/>
              <a:t>5/1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0EC32C-AA53-4B5C-B74D-D7A8E62654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0328559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5831E4-474B-4F25-B22E-82D05E314CF4}" type="datetimeFigureOut">
              <a:rPr lang="en-US" smtClean="0"/>
              <a:t>5/1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0EC32C-AA53-4B5C-B74D-D7A8E62654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7121593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5831E4-474B-4F25-B22E-82D05E314CF4}" type="datetimeFigureOut">
              <a:rPr lang="en-US" smtClean="0"/>
              <a:t>5/1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0EC32C-AA53-4B5C-B74D-D7A8E62654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216844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5831E4-474B-4F25-B22E-82D05E314CF4}" type="datetimeFigureOut">
              <a:rPr lang="en-US" smtClean="0"/>
              <a:t>5/1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0EC32C-AA53-4B5C-B74D-D7A8E62654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7321798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5831E4-474B-4F25-B22E-82D05E314CF4}" type="datetimeFigureOut">
              <a:rPr lang="en-US" smtClean="0"/>
              <a:t>5/1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0EC32C-AA53-4B5C-B74D-D7A8E62654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715017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5831E4-474B-4F25-B22E-82D05E314CF4}" type="datetimeFigureOut">
              <a:rPr lang="en-US" smtClean="0"/>
              <a:t>5/15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0EC32C-AA53-4B5C-B74D-D7A8E62654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7029965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5831E4-474B-4F25-B22E-82D05E314CF4}" type="datetimeFigureOut">
              <a:rPr lang="en-US" smtClean="0"/>
              <a:t>5/15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0EC32C-AA53-4B5C-B74D-D7A8E62654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070868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5831E4-474B-4F25-B22E-82D05E314CF4}" type="datetimeFigureOut">
              <a:rPr lang="en-US" smtClean="0"/>
              <a:t>5/15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0EC32C-AA53-4B5C-B74D-D7A8E62654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9828422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5831E4-474B-4F25-B22E-82D05E314CF4}" type="datetimeFigureOut">
              <a:rPr lang="en-US" smtClean="0"/>
              <a:t>5/15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0EC32C-AA53-4B5C-B74D-D7A8E62654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572444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5831E4-474B-4F25-B22E-82D05E314CF4}" type="datetimeFigureOut">
              <a:rPr lang="en-US" smtClean="0"/>
              <a:t>5/15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0EC32C-AA53-4B5C-B74D-D7A8E62654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6151182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5831E4-474B-4F25-B22E-82D05E314CF4}" type="datetimeFigureOut">
              <a:rPr lang="en-US" smtClean="0"/>
              <a:t>5/15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0EC32C-AA53-4B5C-B74D-D7A8E62654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2943796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D5831E4-474B-4F25-B22E-82D05E314CF4}" type="datetimeFigureOut">
              <a:rPr lang="en-US" smtClean="0"/>
              <a:t>5/1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B0EC32C-AA53-4B5C-B74D-D7A8E62654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2227898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121" name="Picture 1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3247" y="4038600"/>
            <a:ext cx="8984553" cy="194534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5122" name="Picture 2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371600" y="152401"/>
            <a:ext cx="7659014" cy="38861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5" name="Rectangle 4"/>
          <p:cNvSpPr/>
          <p:nvPr/>
        </p:nvSpPr>
        <p:spPr>
          <a:xfrm>
            <a:off x="381000" y="368595"/>
            <a:ext cx="82259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PSTT-2</a:t>
            </a:r>
          </a:p>
        </p:txBody>
      </p:sp>
      <p:sp>
        <p:nvSpPr>
          <p:cNvPr id="2" name="Rectangle 1"/>
          <p:cNvSpPr/>
          <p:nvPr/>
        </p:nvSpPr>
        <p:spPr>
          <a:xfrm>
            <a:off x="83247" y="5962650"/>
            <a:ext cx="8984553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/>
              <a:t>S8 Fig:  </a:t>
            </a:r>
            <a:r>
              <a:rPr lang="en-US" dirty="0"/>
              <a:t>Chromosomal microarray performed on DNA extracted from FFPE tissue using the </a:t>
            </a:r>
            <a:r>
              <a:rPr lang="en-US" dirty="0" err="1"/>
              <a:t>OncoScan</a:t>
            </a:r>
            <a:r>
              <a:rPr lang="en-US" dirty="0"/>
              <a:t> CNV Plus assay for PSTT-2.  PSTT-2 was classified as negative for copy number alterations and genomic deletions affecting </a:t>
            </a:r>
            <a:r>
              <a:rPr lang="en-US" i="1" dirty="0"/>
              <a:t>LPCAT1 </a:t>
            </a:r>
            <a:r>
              <a:rPr lang="en-US" dirty="0"/>
              <a:t>or </a:t>
            </a:r>
            <a:r>
              <a:rPr lang="en-US" i="1" dirty="0"/>
              <a:t>TERT.</a:t>
            </a:r>
            <a:endParaRPr lang="en-US" dirty="0"/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23377001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882</TotalTime>
  <Words>78</Words>
  <Application>Microsoft Office PowerPoint</Application>
  <PresentationFormat>On-screen Show (4:3)</PresentationFormat>
  <Paragraphs>6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Company>Mayo Clinic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icole L Hoppman</dc:creator>
  <cp:lastModifiedBy>chn off31</cp:lastModifiedBy>
  <cp:revision>24</cp:revision>
  <dcterms:created xsi:type="dcterms:W3CDTF">2019-10-11T15:47:09Z</dcterms:created>
  <dcterms:modified xsi:type="dcterms:W3CDTF">2021-05-15T05:15:33Z</dcterms:modified>
</cp:coreProperties>
</file>